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280" r:id="rId3"/>
    <p:sldId id="282" r:id="rId4"/>
    <p:sldId id="286" r:id="rId5"/>
    <p:sldId id="264" r:id="rId6"/>
    <p:sldId id="283" r:id="rId7"/>
    <p:sldId id="287" r:id="rId8"/>
    <p:sldId id="285" r:id="rId9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0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olf, Sonia N" initials="WSN" lastIdx="7" clrIdx="0">
    <p:extLst>
      <p:ext uri="{19B8F6BF-5375-455C-9EA6-DF929625EA0E}">
        <p15:presenceInfo xmlns:p15="http://schemas.microsoft.com/office/powerpoint/2012/main" userId="S::snw02@ic.ac.uk::83f4ff5f-e4ea-45cf-86f5-c50ea1e8761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2" d="100"/>
          <a:sy n="112" d="100"/>
        </p:scale>
        <p:origin x="192" y="-2448"/>
      </p:cViewPr>
      <p:guideLst>
        <p:guide orient="horz" pos="310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commentAuthors" Target="commentAuthor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564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566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82747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1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663"/>
            </a:lvl1pPr>
            <a:lvl2pPr marL="316523" indent="0" algn="ctr">
              <a:buNone/>
              <a:defRPr sz="1385"/>
            </a:lvl2pPr>
            <a:lvl3pPr marL="633047" indent="0" algn="ctr">
              <a:buNone/>
              <a:defRPr sz="1247"/>
            </a:lvl3pPr>
            <a:lvl4pPr marL="949570" indent="0" algn="ctr">
              <a:buNone/>
              <a:defRPr sz="1108"/>
            </a:lvl4pPr>
            <a:lvl5pPr marL="1266092" indent="0" algn="ctr">
              <a:buNone/>
              <a:defRPr sz="1108"/>
            </a:lvl5pPr>
            <a:lvl6pPr marL="1582615" indent="0" algn="ctr">
              <a:buNone/>
              <a:defRPr sz="1108"/>
            </a:lvl6pPr>
            <a:lvl7pPr marL="1899139" indent="0" algn="ctr">
              <a:buNone/>
              <a:defRPr sz="1108"/>
            </a:lvl7pPr>
            <a:lvl8pPr marL="2215662" indent="0" algn="ctr">
              <a:buNone/>
              <a:defRPr sz="1108"/>
            </a:lvl8pPr>
            <a:lvl9pPr marL="2532185" indent="0" algn="ctr">
              <a:buNone/>
              <a:defRPr sz="110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5287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192997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4"/>
            <a:ext cx="5915025" cy="3803649"/>
          </a:xfrm>
        </p:spPr>
        <p:txBody>
          <a:bodyPr anchor="b"/>
          <a:lstStyle>
            <a:lvl1pPr>
              <a:defRPr sz="41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5"/>
            <a:ext cx="5915025" cy="2000251"/>
          </a:xfrm>
        </p:spPr>
        <p:txBody>
          <a:bodyPr/>
          <a:lstStyle>
            <a:lvl1pPr marL="0" indent="0">
              <a:buNone/>
              <a:defRPr sz="1663">
                <a:solidFill>
                  <a:schemeClr val="tx1"/>
                </a:solidFill>
              </a:defRPr>
            </a:lvl1pPr>
            <a:lvl2pPr marL="316523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47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3pPr>
            <a:lvl4pPr marL="949570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092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615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3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662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185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25768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36213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663" b="1"/>
            </a:lvl1pPr>
            <a:lvl2pPr marL="316523" indent="0">
              <a:buNone/>
              <a:defRPr sz="1385" b="1"/>
            </a:lvl2pPr>
            <a:lvl3pPr marL="633047" indent="0">
              <a:buNone/>
              <a:defRPr sz="1247" b="1"/>
            </a:lvl3pPr>
            <a:lvl4pPr marL="949570" indent="0">
              <a:buNone/>
              <a:defRPr sz="1108" b="1"/>
            </a:lvl4pPr>
            <a:lvl5pPr marL="1266092" indent="0">
              <a:buNone/>
              <a:defRPr sz="1108" b="1"/>
            </a:lvl5pPr>
            <a:lvl6pPr marL="1582615" indent="0">
              <a:buNone/>
              <a:defRPr sz="1108" b="1"/>
            </a:lvl6pPr>
            <a:lvl7pPr marL="1899139" indent="0">
              <a:buNone/>
              <a:defRPr sz="1108" b="1"/>
            </a:lvl7pPr>
            <a:lvl8pPr marL="2215662" indent="0">
              <a:buNone/>
              <a:defRPr sz="1108" b="1"/>
            </a:lvl8pPr>
            <a:lvl9pPr marL="2532185" indent="0">
              <a:buNone/>
              <a:defRPr sz="1108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2"/>
            <a:ext cx="2915543" cy="1098549"/>
          </a:xfrm>
        </p:spPr>
        <p:txBody>
          <a:bodyPr anchor="b"/>
          <a:lstStyle>
            <a:lvl1pPr marL="0" indent="0">
              <a:buNone/>
              <a:defRPr sz="1663" b="1"/>
            </a:lvl1pPr>
            <a:lvl2pPr marL="316523" indent="0">
              <a:buNone/>
              <a:defRPr sz="1385" b="1"/>
            </a:lvl2pPr>
            <a:lvl3pPr marL="633047" indent="0">
              <a:buNone/>
              <a:defRPr sz="1247" b="1"/>
            </a:lvl3pPr>
            <a:lvl4pPr marL="949570" indent="0">
              <a:buNone/>
              <a:defRPr sz="1108" b="1"/>
            </a:lvl4pPr>
            <a:lvl5pPr marL="1266092" indent="0">
              <a:buNone/>
              <a:defRPr sz="1108" b="1"/>
            </a:lvl5pPr>
            <a:lvl6pPr marL="1582615" indent="0">
              <a:buNone/>
              <a:defRPr sz="1108" b="1"/>
            </a:lvl6pPr>
            <a:lvl7pPr marL="1899139" indent="0">
              <a:buNone/>
              <a:defRPr sz="1108" b="1"/>
            </a:lvl7pPr>
            <a:lvl8pPr marL="2215662" indent="0">
              <a:buNone/>
              <a:defRPr sz="1108" b="1"/>
            </a:lvl8pPr>
            <a:lvl9pPr marL="2532185" indent="0">
              <a:buNone/>
              <a:defRPr sz="1108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1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19480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34103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57650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0"/>
            <a:ext cx="3471863" cy="6498167"/>
          </a:xfrm>
        </p:spPr>
        <p:txBody>
          <a:bodyPr/>
          <a:lstStyle>
            <a:lvl1pPr>
              <a:defRPr sz="2215"/>
            </a:lvl1pPr>
            <a:lvl2pPr>
              <a:defRPr sz="1939"/>
            </a:lvl2pPr>
            <a:lvl3pPr>
              <a:defRPr sz="1663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108"/>
            </a:lvl1pPr>
            <a:lvl2pPr marL="316523" indent="0">
              <a:buNone/>
              <a:defRPr sz="969"/>
            </a:lvl2pPr>
            <a:lvl3pPr marL="633047" indent="0">
              <a:buNone/>
              <a:defRPr sz="831"/>
            </a:lvl3pPr>
            <a:lvl4pPr marL="949570" indent="0">
              <a:buNone/>
              <a:defRPr sz="692"/>
            </a:lvl4pPr>
            <a:lvl5pPr marL="1266092" indent="0">
              <a:buNone/>
              <a:defRPr sz="692"/>
            </a:lvl5pPr>
            <a:lvl6pPr marL="1582615" indent="0">
              <a:buNone/>
              <a:defRPr sz="692"/>
            </a:lvl6pPr>
            <a:lvl7pPr marL="1899139" indent="0">
              <a:buNone/>
              <a:defRPr sz="692"/>
            </a:lvl7pPr>
            <a:lvl8pPr marL="2215662" indent="0">
              <a:buNone/>
              <a:defRPr sz="692"/>
            </a:lvl8pPr>
            <a:lvl9pPr marL="2532185" indent="0">
              <a:buNone/>
              <a:defRPr sz="69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882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348392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0"/>
            <a:ext cx="3471863" cy="6498167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23" indent="0">
              <a:buNone/>
              <a:defRPr sz="1939"/>
            </a:lvl2pPr>
            <a:lvl3pPr marL="633047" indent="0">
              <a:buNone/>
              <a:defRPr sz="1663"/>
            </a:lvl3pPr>
            <a:lvl4pPr marL="949570" indent="0">
              <a:buNone/>
              <a:defRPr sz="1385"/>
            </a:lvl4pPr>
            <a:lvl5pPr marL="1266092" indent="0">
              <a:buNone/>
              <a:defRPr sz="1385"/>
            </a:lvl5pPr>
            <a:lvl6pPr marL="1582615" indent="0">
              <a:buNone/>
              <a:defRPr sz="1385"/>
            </a:lvl6pPr>
            <a:lvl7pPr marL="1899139" indent="0">
              <a:buNone/>
              <a:defRPr sz="1385"/>
            </a:lvl7pPr>
            <a:lvl8pPr marL="2215662" indent="0">
              <a:buNone/>
              <a:defRPr sz="1385"/>
            </a:lvl8pPr>
            <a:lvl9pPr marL="2532185" indent="0">
              <a:buNone/>
              <a:defRPr sz="138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108"/>
            </a:lvl1pPr>
            <a:lvl2pPr marL="316523" indent="0">
              <a:buNone/>
              <a:defRPr sz="969"/>
            </a:lvl2pPr>
            <a:lvl3pPr marL="633047" indent="0">
              <a:buNone/>
              <a:defRPr sz="831"/>
            </a:lvl3pPr>
            <a:lvl4pPr marL="949570" indent="0">
              <a:buNone/>
              <a:defRPr sz="692"/>
            </a:lvl4pPr>
            <a:lvl5pPr marL="1266092" indent="0">
              <a:buNone/>
              <a:defRPr sz="692"/>
            </a:lvl5pPr>
            <a:lvl6pPr marL="1582615" indent="0">
              <a:buNone/>
              <a:defRPr sz="692"/>
            </a:lvl6pPr>
            <a:lvl7pPr marL="1899139" indent="0">
              <a:buNone/>
              <a:defRPr sz="692"/>
            </a:lvl7pPr>
            <a:lvl8pPr marL="2215662" indent="0">
              <a:buNone/>
              <a:defRPr sz="692"/>
            </a:lvl8pPr>
            <a:lvl9pPr marL="2532185" indent="0">
              <a:buNone/>
              <a:defRPr sz="69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4814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42518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233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1549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272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201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4961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9064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6210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2116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1E6CD-A562-4D6D-B423-42766CC0BA17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FB106C-0EEC-4758-8C37-DF45D646F8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4801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E0DE2-CCFA-49D3-90F5-E96606CDBB21}" type="datetimeFigureOut">
              <a:rPr lang="en-GB" smtClean="0"/>
              <a:t>2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36"/>
            <a:ext cx="2314575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71223-7F6A-4030-868A-BEE33B4A3A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434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33047" rtl="0" eaLnBrk="1" latinLnBrk="0" hangingPunct="1">
        <a:lnSpc>
          <a:spcPct val="90000"/>
        </a:lnSpc>
        <a:spcBef>
          <a:spcPct val="0"/>
        </a:spcBef>
        <a:buNone/>
        <a:defRPr sz="30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1" indent="-158261" algn="l" defTabSz="633047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sz="1939" kern="1200">
          <a:solidFill>
            <a:schemeClr val="tx1"/>
          </a:solidFill>
          <a:latin typeface="+mn-lt"/>
          <a:ea typeface="+mn-ea"/>
          <a:cs typeface="+mn-cs"/>
        </a:defRPr>
      </a:lvl1pPr>
      <a:lvl2pPr marL="474784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663" kern="1200">
          <a:solidFill>
            <a:schemeClr val="tx1"/>
          </a:solidFill>
          <a:latin typeface="+mn-lt"/>
          <a:ea typeface="+mn-ea"/>
          <a:cs typeface="+mn-cs"/>
        </a:defRPr>
      </a:lvl2pPr>
      <a:lvl3pPr marL="791307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31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4pPr>
      <a:lvl5pPr marL="1424354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5pPr>
      <a:lvl6pPr marL="1740876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6pPr>
      <a:lvl7pPr marL="2057399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7pPr>
      <a:lvl8pPr marL="2373923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8pPr>
      <a:lvl9pPr marL="2690446" indent="-158261" algn="l" defTabSz="633047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1pPr>
      <a:lvl2pPr marL="316523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2pPr>
      <a:lvl3pPr marL="633047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3pPr>
      <a:lvl4pPr marL="949570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4pPr>
      <a:lvl5pPr marL="1266092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5pPr>
      <a:lvl6pPr marL="1582615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6pPr>
      <a:lvl7pPr marL="1899139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7pPr>
      <a:lvl8pPr marL="2215662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8pPr>
      <a:lvl9pPr marL="2532185" algn="l" defTabSz="633047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10" Type="http://schemas.openxmlformats.org/officeDocument/2006/relationships/image" Target="../media/image18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8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9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2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1.emf"/><Relationship Id="rId11" Type="http://schemas.openxmlformats.org/officeDocument/2006/relationships/oleObject" Target="../embeddings/oleObject6.bin"/><Relationship Id="rId5" Type="http://schemas.openxmlformats.org/officeDocument/2006/relationships/oleObject" Target="../embeddings/oleObject3.bin"/><Relationship Id="rId10" Type="http://schemas.openxmlformats.org/officeDocument/2006/relationships/image" Target="../media/image23.emf"/><Relationship Id="rId4" Type="http://schemas.openxmlformats.org/officeDocument/2006/relationships/image" Target="../media/image20.emf"/><Relationship Id="rId9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1AB7084-9426-49FE-BE80-BB2D98A724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3460533"/>
              </p:ext>
            </p:extLst>
          </p:nvPr>
        </p:nvGraphicFramePr>
        <p:xfrm>
          <a:off x="1361757" y="782307"/>
          <a:ext cx="4134485" cy="6177534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852805">
                  <a:extLst>
                    <a:ext uri="{9D8B030D-6E8A-4147-A177-3AD203B41FA5}">
                      <a16:colId xmlns:a16="http://schemas.microsoft.com/office/drawing/2014/main" val="2166292249"/>
                    </a:ext>
                  </a:extLst>
                </a:gridCol>
                <a:gridCol w="579755">
                  <a:extLst>
                    <a:ext uri="{9D8B030D-6E8A-4147-A177-3AD203B41FA5}">
                      <a16:colId xmlns:a16="http://schemas.microsoft.com/office/drawing/2014/main" val="2669347601"/>
                    </a:ext>
                  </a:extLst>
                </a:gridCol>
                <a:gridCol w="970091">
                  <a:extLst>
                    <a:ext uri="{9D8B030D-6E8A-4147-A177-3AD203B41FA5}">
                      <a16:colId xmlns:a16="http://schemas.microsoft.com/office/drawing/2014/main" val="1871864263"/>
                    </a:ext>
                  </a:extLst>
                </a:gridCol>
                <a:gridCol w="1731834">
                  <a:extLst>
                    <a:ext uri="{9D8B030D-6E8A-4147-A177-3AD203B41FA5}">
                      <a16:colId xmlns:a16="http://schemas.microsoft.com/office/drawing/2014/main" val="135621926"/>
                    </a:ext>
                  </a:extLst>
                </a:gridCol>
              </a:tblGrid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Target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luo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lon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Suppli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736099472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Dead cell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I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/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49185062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CR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V4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L291H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05207600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V5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UCHT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642127291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V6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RPA-T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835716521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Cy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a5b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33027495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P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7-6B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62307393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F7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RPA-T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797364973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Ki-6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V7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Ki-6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iolege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018145053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L37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2425900150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PE/FITC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PB2D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654330589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H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776392161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WJF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1263477732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5.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MMU15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029509619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5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621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42228944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5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D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806665786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7.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ZO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1560878330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7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ZIZOU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2993016029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56C5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1847080289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N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669130117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491918355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ER2.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2313986473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3.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MU2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510877299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3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H1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739681239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3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JU74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4075189384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AS1.1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4005740864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AMAYA1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1872701228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E17.5F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66766668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1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A62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Beckman Coulte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507251848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2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ELL1.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4259751040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21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G12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4188125007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/FI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MMU54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eckman Coult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1435931598"/>
                  </a:ext>
                </a:extLst>
              </a:tr>
              <a:tr h="174625"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V</a:t>
                      </a:r>
                      <a:r>
                        <a:rPr lang="el-GR" sz="1100">
                          <a:effectLst/>
                        </a:rPr>
                        <a:t>β 2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F2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Beckman Coulte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b"/>
                </a:tc>
                <a:extLst>
                  <a:ext uri="{0D108BD9-81ED-4DB2-BD59-A6C34878D82A}">
                    <a16:rowId xmlns:a16="http://schemas.microsoft.com/office/drawing/2014/main" val="360908042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6243779-4534-4805-8AB4-FB640101B638}"/>
              </a:ext>
            </a:extLst>
          </p:cNvPr>
          <p:cNvSpPr txBox="1"/>
          <p:nvPr/>
        </p:nvSpPr>
        <p:spPr>
          <a:xfrm>
            <a:off x="726139" y="7372494"/>
            <a:ext cx="40800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Supplementary </a:t>
            </a:r>
            <a:r>
              <a:rPr lang="en-GB" sz="1000" b="1" dirty="0" smtClean="0"/>
              <a:t>table 2. </a:t>
            </a:r>
            <a:r>
              <a:rPr lang="en-GB" sz="1000" dirty="0"/>
              <a:t>Antibody panel used for staining cells.</a:t>
            </a:r>
          </a:p>
          <a:p>
            <a:r>
              <a:rPr lang="en-GB" sz="1000" dirty="0"/>
              <a:t>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ED8E1AC-576C-4716-84B0-E6633C859222}"/>
              </a:ext>
            </a:extLst>
          </p:cNvPr>
          <p:cNvSpPr txBox="1"/>
          <p:nvPr/>
        </p:nvSpPr>
        <p:spPr>
          <a:xfrm>
            <a:off x="726139" y="257175"/>
            <a:ext cx="3036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 table 2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4463081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D4F418E-16AC-4A23-B287-702F99EA90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1424301"/>
              </p:ext>
            </p:extLst>
          </p:nvPr>
        </p:nvGraphicFramePr>
        <p:xfrm>
          <a:off x="448761" y="637485"/>
          <a:ext cx="6065121" cy="7976875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808298">
                  <a:extLst>
                    <a:ext uri="{9D8B030D-6E8A-4147-A177-3AD203B41FA5}">
                      <a16:colId xmlns:a16="http://schemas.microsoft.com/office/drawing/2014/main" val="2126778688"/>
                    </a:ext>
                  </a:extLst>
                </a:gridCol>
                <a:gridCol w="2788627">
                  <a:extLst>
                    <a:ext uri="{9D8B030D-6E8A-4147-A177-3AD203B41FA5}">
                      <a16:colId xmlns:a16="http://schemas.microsoft.com/office/drawing/2014/main" val="1303011057"/>
                    </a:ext>
                  </a:extLst>
                </a:gridCol>
                <a:gridCol w="564412">
                  <a:extLst>
                    <a:ext uri="{9D8B030D-6E8A-4147-A177-3AD203B41FA5}">
                      <a16:colId xmlns:a16="http://schemas.microsoft.com/office/drawing/2014/main" val="2933220556"/>
                    </a:ext>
                  </a:extLst>
                </a:gridCol>
                <a:gridCol w="619125">
                  <a:extLst>
                    <a:ext uri="{9D8B030D-6E8A-4147-A177-3AD203B41FA5}">
                      <a16:colId xmlns:a16="http://schemas.microsoft.com/office/drawing/2014/main" val="3408953111"/>
                    </a:ext>
                  </a:extLst>
                </a:gridCol>
                <a:gridCol w="1284659">
                  <a:extLst>
                    <a:ext uri="{9D8B030D-6E8A-4147-A177-3AD203B41FA5}">
                      <a16:colId xmlns:a16="http://schemas.microsoft.com/office/drawing/2014/main" val="3553859229"/>
                    </a:ext>
                  </a:extLst>
                </a:gridCol>
              </a:tblGrid>
              <a:tr h="11788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Reference range: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832243664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b="1" u="none" strike="noStrike" dirty="0">
                          <a:effectLst/>
                        </a:rPr>
                        <a:t>Training cohort</a:t>
                      </a:r>
                      <a:r>
                        <a:rPr lang="en-GB" sz="800" u="none" strike="noStrike" dirty="0">
                          <a:effectLst/>
                        </a:rPr>
                        <a:t>: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600042802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n=38 HTLV carriers without AT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>
                          <a:effectLst/>
                        </a:rPr>
                        <a:t>Min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>
                          <a:effectLst/>
                        </a:rPr>
                        <a:t>Max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Median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475350837"/>
                  </a:ext>
                </a:extLst>
              </a:tr>
              <a:tr h="59956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Length of clinical follow up (months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8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2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12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803971961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PVL (copies of Tax/100 PBMC)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8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7.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397346968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Age (years)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2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7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423056852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010498207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>
                          <a:effectLst/>
                        </a:rPr>
                        <a:t>Lower bound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Upper boun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492195794"/>
                  </a:ext>
                </a:extLst>
              </a:tr>
              <a:tr h="210593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Key figure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% of total CCR4+CD26- cells expressing CD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48.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29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% of total CCR4+CD26-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754218090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Gini of CD3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9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77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4022777911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% Ki-67+ in CD3+CD4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3.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% of paren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460955028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>
                          <a:effectLst/>
                        </a:rPr>
                        <a:t>*% CD7- in CD3+CD4+CCR4+CD26- T cells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3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79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% of paren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300675043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990372295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Lower boun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Upper boun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591792463"/>
                  </a:ext>
                </a:extLst>
              </a:tr>
              <a:tr h="11788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Oligoclonality score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dirty="0" smtClean="0">
                          <a:effectLst/>
                        </a:rPr>
                        <a:t>OCI-flow</a:t>
                      </a:r>
                      <a:r>
                        <a:rPr lang="fr-FR" sz="800" u="none" strike="noStrike" baseline="0" dirty="0" smtClean="0">
                          <a:effectLst/>
                        </a:rPr>
                        <a:t>: Oligoclonality of </a:t>
                      </a:r>
                      <a:r>
                        <a:rPr lang="fr-FR" sz="800" u="none" strike="noStrike" dirty="0" smtClean="0">
                          <a:effectLst/>
                        </a:rPr>
                        <a:t>CD3+CCR4+CD26- </a:t>
                      </a:r>
                      <a:r>
                        <a:rPr lang="fr-FR" sz="800" u="none" strike="noStrike" dirty="0">
                          <a:effectLst/>
                        </a:rPr>
                        <a:t>T </a:t>
                      </a:r>
                      <a:r>
                        <a:rPr lang="fr-FR" sz="800" u="none" strike="noStrike" dirty="0" err="1">
                          <a:effectLst/>
                        </a:rPr>
                        <a:t>cell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9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0.77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583864545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baseline="0" dirty="0" smtClean="0">
                          <a:effectLst/>
                        </a:rPr>
                        <a:t>Oligoclonality of</a:t>
                      </a:r>
                      <a:r>
                        <a:rPr lang="en-GB" sz="800" u="none" strike="noStrike" dirty="0" smtClean="0">
                          <a:effectLst/>
                        </a:rPr>
                        <a:t> </a:t>
                      </a:r>
                      <a:r>
                        <a:rPr lang="en-GB" sz="800" u="none" strike="noStrike" dirty="0">
                          <a:effectLst/>
                        </a:rPr>
                        <a:t>rest of CD3+ T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3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74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000112753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baseline="0" dirty="0" smtClean="0">
                          <a:effectLst/>
                        </a:rPr>
                        <a:t>Oligoclonality of </a:t>
                      </a:r>
                      <a:r>
                        <a:rPr lang="fr-FR" sz="800" u="none" strike="noStrike" dirty="0" smtClean="0">
                          <a:effectLst/>
                        </a:rPr>
                        <a:t>CD4+CCR4+CD26- </a:t>
                      </a:r>
                      <a:r>
                        <a:rPr lang="fr-FR" sz="800" u="none" strike="noStrike" dirty="0">
                          <a:effectLst/>
                        </a:rPr>
                        <a:t>T </a:t>
                      </a:r>
                      <a:r>
                        <a:rPr lang="fr-FR" sz="800" u="none" strike="noStrike" dirty="0" err="1">
                          <a:effectLst/>
                        </a:rPr>
                        <a:t>cell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2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6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847408231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baseline="0" dirty="0" smtClean="0">
                          <a:effectLst/>
                        </a:rPr>
                        <a:t>Oligoclonality of</a:t>
                      </a:r>
                      <a:r>
                        <a:rPr lang="en-GB" sz="800" u="none" strike="noStrike" dirty="0" smtClean="0">
                          <a:effectLst/>
                        </a:rPr>
                        <a:t> </a:t>
                      </a:r>
                      <a:r>
                        <a:rPr lang="en-GB" sz="800" u="none" strike="noStrike" dirty="0">
                          <a:effectLst/>
                        </a:rPr>
                        <a:t>rest of CD4+ T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1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62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4166966082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baseline="0" dirty="0" smtClean="0">
                          <a:effectLst/>
                        </a:rPr>
                        <a:t>Oligoclonality of </a:t>
                      </a:r>
                      <a:r>
                        <a:rPr lang="fr-FR" sz="800" u="none" strike="noStrike" dirty="0" smtClean="0">
                          <a:effectLst/>
                        </a:rPr>
                        <a:t>CD8+CCR4+CD26- </a:t>
                      </a:r>
                      <a:r>
                        <a:rPr lang="fr-FR" sz="800" u="none" strike="noStrike" dirty="0">
                          <a:effectLst/>
                        </a:rPr>
                        <a:t>T </a:t>
                      </a:r>
                      <a:r>
                        <a:rPr lang="fr-FR" sz="800" u="none" strike="noStrike" dirty="0" err="1">
                          <a:effectLst/>
                        </a:rPr>
                        <a:t>cell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3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8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183008546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baseline="0" dirty="0" smtClean="0">
                          <a:effectLst/>
                        </a:rPr>
                        <a:t>Oligoclonality of</a:t>
                      </a:r>
                      <a:r>
                        <a:rPr lang="en-GB" sz="800" u="none" strike="noStrike" dirty="0" smtClean="0">
                          <a:effectLst/>
                        </a:rPr>
                        <a:t> </a:t>
                      </a:r>
                      <a:r>
                        <a:rPr lang="en-GB" sz="800" u="none" strike="noStrike" dirty="0">
                          <a:effectLst/>
                        </a:rPr>
                        <a:t>rest of CD8+ T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1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85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385313370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843741858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* proportional to load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>
                          <a:effectLst/>
                        </a:rPr>
                        <a:t>Lower bound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Upper boun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159876672"/>
                  </a:ext>
                </a:extLst>
              </a:tr>
              <a:tr h="21059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Freq. and CD3 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% of CCR4+CD26- cells expressing CD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8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129.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total CCR4+CD26-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4126998328"/>
                  </a:ext>
                </a:extLst>
              </a:tr>
              <a:tr h="1417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*Freq. of CCR4+CD26- cells in lymphocyt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6.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live lymphocyt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496825691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>
                          <a:effectLst/>
                        </a:rPr>
                        <a:t>*Total freq. CD3+CCR4+CD26- T cells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4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612175658"/>
                  </a:ext>
                </a:extLst>
              </a:tr>
              <a:tr h="11788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Dominant TCRVB subunit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>
                          <a:effectLst/>
                        </a:rPr>
                        <a:t>Freq. Dominant subunit in CD3+CCR4+CD26- T cells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3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53028348"/>
                  </a:ext>
                </a:extLst>
              </a:tr>
              <a:tr h="2105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800" u="none" strike="noStrike" dirty="0" err="1">
                          <a:effectLst/>
                        </a:rPr>
                        <a:t>Freq</a:t>
                      </a:r>
                      <a:r>
                        <a:rPr lang="fr-FR" sz="800" u="none" strike="noStrike" dirty="0">
                          <a:effectLst/>
                        </a:rPr>
                        <a:t>. Dominant </a:t>
                      </a:r>
                      <a:r>
                        <a:rPr lang="fr-FR" sz="800" u="none" strike="noStrike" dirty="0" err="1">
                          <a:effectLst/>
                        </a:rPr>
                        <a:t>subunit</a:t>
                      </a:r>
                      <a:r>
                        <a:rPr lang="fr-FR" sz="800" u="none" strike="noStrike" dirty="0">
                          <a:effectLst/>
                        </a:rPr>
                        <a:t> in CD3+CCR4+CD26- T </a:t>
                      </a:r>
                      <a:r>
                        <a:rPr lang="fr-FR" sz="800" u="none" strike="noStrike" dirty="0" err="1">
                          <a:effectLst/>
                        </a:rPr>
                        <a:t>cell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7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4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690270624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CD4+CCR4+CD26- dominant subuni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2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291976754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CD4+ rest dominant subuni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4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445249205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CD8+CCR4+CD26- dominant subuni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646020274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CD8+ rest dominant subuni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1.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703620145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729666375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Frequency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68717095"/>
                  </a:ext>
                </a:extLst>
              </a:tr>
              <a:tr h="11788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T cell subset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total CD4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.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97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629877089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*Freq. of CD4+CCR4+CD26- T cells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9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933471343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rest of CD4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9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79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942284253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total CD8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15.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73.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577154116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CD8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9.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995093741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rest of CD8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3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68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CD3+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866685208"/>
                  </a:ext>
                </a:extLst>
              </a:tr>
              <a:tr h="11788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CD4:CD8 ratio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 dirty="0">
                          <a:effectLst/>
                        </a:rPr>
                        <a:t>CD4+:CD8+ in CCR4+CD26- T cells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.2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8.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865277914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CD4+:CD8+ in rest of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3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.1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995537623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CD4+:CD8+ in total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6.0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50189477"/>
                  </a:ext>
                </a:extLst>
              </a:tr>
              <a:tr h="11788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CD7dim/- cell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>
                          <a:effectLst/>
                        </a:rPr>
                        <a:t>% *CD7- in CD4+CCR4+CD26- T cells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3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79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913440777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% CD7- in rest of CD4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6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1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730871216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>
                          <a:effectLst/>
                        </a:rPr>
                        <a:t>% CD7- in CD8+CCR4+CD26- T cells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6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1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585903080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% CD7- in rest of CD8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9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381454059"/>
                  </a:ext>
                </a:extLst>
              </a:tr>
              <a:tr h="11788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Ki-67+ cell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% Ki-67+ in CD4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3.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962431474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% Ki-67+ in rest of CD4+ T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8866085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% Ki-67+ in CD8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3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743665862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% Ki-67+ in rest of CD8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of par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616235992"/>
                  </a:ext>
                </a:extLst>
              </a:tr>
              <a:tr h="117880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435180748"/>
                  </a:ext>
                </a:extLst>
              </a:tr>
              <a:tr h="11788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Variability between 8 tubes staine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Lower boun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Upper boun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738958810"/>
                  </a:ext>
                </a:extLst>
              </a:tr>
              <a:tr h="11788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T cell subset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*Freq. of CD4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7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518624603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rest of CD4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038856893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Freq. of CD8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15.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4050937265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Freq. of rest of CD8+ T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575528603"/>
                  </a:ext>
                </a:extLst>
              </a:tr>
              <a:tr h="11788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CD7 dim/-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>
                          <a:effectLst/>
                        </a:rPr>
                        <a:t>*CD7- in CD4+CCR4+CD26- T cells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6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683637127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CD7- in rest of CD4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0.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.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1365569412"/>
                  </a:ext>
                </a:extLst>
              </a:tr>
              <a:tr h="11788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effectLst/>
                        </a:rPr>
                        <a:t>Ki-67 +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Ki-67+ in CD4+CCR4+CD26-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1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26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% C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436678322"/>
                  </a:ext>
                </a:extLst>
              </a:tr>
              <a:tr h="11788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Ki-67+ in rest of CD4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42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% CV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2551580169"/>
                  </a:ext>
                </a:extLst>
              </a:tr>
              <a:tr h="132126">
                <a:tc>
                  <a:txBody>
                    <a:bodyPr/>
                    <a:lstStyle/>
                    <a:p>
                      <a:pPr algn="l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88" marR="4188" marT="4188" marB="0" anchor="b"/>
                </a:tc>
                <a:extLst>
                  <a:ext uri="{0D108BD9-81ED-4DB2-BD59-A6C34878D82A}">
                    <a16:rowId xmlns:a16="http://schemas.microsoft.com/office/drawing/2014/main" val="349595624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F8FDDC5-DEA6-48BD-ABEA-BCC88D39319C}"/>
              </a:ext>
            </a:extLst>
          </p:cNvPr>
          <p:cNvSpPr txBox="1"/>
          <p:nvPr/>
        </p:nvSpPr>
        <p:spPr>
          <a:xfrm>
            <a:off x="243367" y="125968"/>
            <a:ext cx="6475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 table 3</a:t>
            </a:r>
            <a:r>
              <a:rPr lang="en-GB" sz="1600" dirty="0" smtClean="0"/>
              <a:t>. </a:t>
            </a:r>
            <a:endParaRPr lang="en-GB" sz="900" dirty="0"/>
          </a:p>
        </p:txBody>
      </p:sp>
      <p:sp>
        <p:nvSpPr>
          <p:cNvPr id="2" name="TextBox 1"/>
          <p:cNvSpPr txBox="1"/>
          <p:nvPr/>
        </p:nvSpPr>
        <p:spPr>
          <a:xfrm>
            <a:off x="1191780" y="128646"/>
            <a:ext cx="56662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Supplementary table 3. </a:t>
            </a:r>
            <a:r>
              <a:rPr lang="en-GB" sz="1000" dirty="0" smtClean="0"/>
              <a:t>A </a:t>
            </a:r>
            <a:r>
              <a:rPr lang="en-GB" sz="1000" dirty="0"/>
              <a:t>reference range was derived from the training cohort (n=38) of HTLV carriers who did not develop ATL after a median of </a:t>
            </a:r>
            <a:r>
              <a:rPr lang="en-GB" sz="1000" dirty="0" smtClean="0"/>
              <a:t>10.5 </a:t>
            </a:r>
            <a:r>
              <a:rPr lang="en-GB" sz="1000" dirty="0"/>
              <a:t>years clinical follow-up. All metrics: 95% Interval of log transformed data, 2 sided.</a:t>
            </a:r>
            <a:endParaRPr lang="en-GB" sz="1000" b="1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982022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64EA3DD3-EBFA-4F56-B7CC-2EABC2EA52D5}"/>
              </a:ext>
            </a:extLst>
          </p:cNvPr>
          <p:cNvSpPr/>
          <p:nvPr/>
        </p:nvSpPr>
        <p:spPr>
          <a:xfrm>
            <a:off x="1016298" y="4219859"/>
            <a:ext cx="482540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 smtClean="0"/>
              <a:t>Supplementary Table 4. </a:t>
            </a:r>
            <a:r>
              <a:rPr lang="en-GB" sz="1100" dirty="0" smtClean="0"/>
              <a:t>(A)Univariate </a:t>
            </a:r>
            <a:r>
              <a:rPr lang="en-GB" sz="1100" dirty="0"/>
              <a:t>logistic regression analysis of the Screening cohort in a model with outcome variable OCI &gt;0.770. Family history includes those with both a confirmed and a possible family history. (B) Based on these findings, multivariate logistic regression was tested in carriers with PVL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≥4%, as no carrier with PVL &lt;4% had an OCI&gt;0.770. </a:t>
            </a:r>
            <a:r>
              <a:rPr lang="en-GB" sz="1100" dirty="0"/>
              <a:t>Sex has been excluded from the multiple regression model due to lack of significance in the univariate analysis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0D3D617-317B-4A3A-9D71-632E09CFB793}"/>
              </a:ext>
            </a:extLst>
          </p:cNvPr>
          <p:cNvSpPr txBox="1"/>
          <p:nvPr/>
        </p:nvSpPr>
        <p:spPr>
          <a:xfrm>
            <a:off x="826862" y="2506956"/>
            <a:ext cx="5651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(B</a:t>
            </a:r>
            <a:r>
              <a:rPr lang="en-GB" sz="1600" b="1" dirty="0" smtClean="0"/>
              <a:t>)</a:t>
            </a:r>
            <a:endParaRPr lang="en-GB" sz="16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0027354-FC36-41BB-8231-82635AD629B6}"/>
              </a:ext>
            </a:extLst>
          </p:cNvPr>
          <p:cNvSpPr txBox="1"/>
          <p:nvPr/>
        </p:nvSpPr>
        <p:spPr>
          <a:xfrm>
            <a:off x="826862" y="794053"/>
            <a:ext cx="537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(A</a:t>
            </a:r>
            <a:r>
              <a:rPr lang="en-GB" sz="1600" b="1" dirty="0" smtClean="0"/>
              <a:t>)</a:t>
            </a:r>
            <a:endParaRPr lang="en-GB" sz="16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32223" y="37542"/>
            <a:ext cx="1021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S Table </a:t>
            </a:r>
            <a:r>
              <a:rPr lang="en-GB" b="1" dirty="0"/>
              <a:t>4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4C44795D-ED03-48A2-BF3F-B21A6BCAA1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7650487"/>
              </p:ext>
            </p:extLst>
          </p:nvPr>
        </p:nvGraphicFramePr>
        <p:xfrm>
          <a:off x="1392048" y="971706"/>
          <a:ext cx="4073904" cy="1174242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648431">
                  <a:extLst>
                    <a:ext uri="{9D8B030D-6E8A-4147-A177-3AD203B41FA5}">
                      <a16:colId xmlns:a16="http://schemas.microsoft.com/office/drawing/2014/main" val="2069954093"/>
                    </a:ext>
                  </a:extLst>
                </a:gridCol>
                <a:gridCol w="717452">
                  <a:extLst>
                    <a:ext uri="{9D8B030D-6E8A-4147-A177-3AD203B41FA5}">
                      <a16:colId xmlns:a16="http://schemas.microsoft.com/office/drawing/2014/main" val="1747829140"/>
                    </a:ext>
                  </a:extLst>
                </a:gridCol>
                <a:gridCol w="956603">
                  <a:extLst>
                    <a:ext uri="{9D8B030D-6E8A-4147-A177-3AD203B41FA5}">
                      <a16:colId xmlns:a16="http://schemas.microsoft.com/office/drawing/2014/main" val="2237972059"/>
                    </a:ext>
                  </a:extLst>
                </a:gridCol>
                <a:gridCol w="751418">
                  <a:extLst>
                    <a:ext uri="{9D8B030D-6E8A-4147-A177-3AD203B41FA5}">
                      <a16:colId xmlns:a16="http://schemas.microsoft.com/office/drawing/2014/main" val="875960057"/>
                    </a:ext>
                  </a:extLst>
                </a:gridCol>
              </a:tblGrid>
              <a:tr h="938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Variabl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 grid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Univariate analysis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1272298"/>
                  </a:ext>
                </a:extLst>
              </a:tr>
              <a:tr h="938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OR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95% CI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2615215353"/>
                  </a:ext>
                </a:extLst>
              </a:tr>
              <a:tr h="938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Ag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9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93-1.0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0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2177192154"/>
                  </a:ext>
                </a:extLst>
              </a:tr>
              <a:tr h="938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VL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.1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.05-1.21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000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2158674331"/>
                  </a:ext>
                </a:extLst>
              </a:tr>
              <a:tr h="938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Lymphocyte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3.1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.48-7.78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00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2170073626"/>
                  </a:ext>
                </a:extLst>
              </a:tr>
              <a:tr h="13370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Family history 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83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.50-21.7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01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3584062314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2C34819-F694-4A56-BDC7-79A5AA0E6E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0875407"/>
              </p:ext>
            </p:extLst>
          </p:nvPr>
        </p:nvGraphicFramePr>
        <p:xfrm>
          <a:off x="1364824" y="2726936"/>
          <a:ext cx="4101129" cy="978535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717858">
                  <a:extLst>
                    <a:ext uri="{9D8B030D-6E8A-4147-A177-3AD203B41FA5}">
                      <a16:colId xmlns:a16="http://schemas.microsoft.com/office/drawing/2014/main" val="1668264530"/>
                    </a:ext>
                  </a:extLst>
                </a:gridCol>
                <a:gridCol w="717452">
                  <a:extLst>
                    <a:ext uri="{9D8B030D-6E8A-4147-A177-3AD203B41FA5}">
                      <a16:colId xmlns:a16="http://schemas.microsoft.com/office/drawing/2014/main" val="2903284202"/>
                    </a:ext>
                  </a:extLst>
                </a:gridCol>
                <a:gridCol w="900333">
                  <a:extLst>
                    <a:ext uri="{9D8B030D-6E8A-4147-A177-3AD203B41FA5}">
                      <a16:colId xmlns:a16="http://schemas.microsoft.com/office/drawing/2014/main" val="3556182745"/>
                    </a:ext>
                  </a:extLst>
                </a:gridCol>
                <a:gridCol w="765486">
                  <a:extLst>
                    <a:ext uri="{9D8B030D-6E8A-4147-A177-3AD203B41FA5}">
                      <a16:colId xmlns:a16="http://schemas.microsoft.com/office/drawing/2014/main" val="621245741"/>
                    </a:ext>
                  </a:extLst>
                </a:gridCol>
              </a:tblGrid>
              <a:tr h="759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 grid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ultivariate analysis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3776274"/>
                  </a:ext>
                </a:extLst>
              </a:tr>
              <a:tr h="759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OR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95% CI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3109538075"/>
                  </a:ext>
                </a:extLst>
              </a:tr>
              <a:tr h="759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&lt;50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13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49-43.64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</a:t>
                      </a: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3636034324"/>
                  </a:ext>
                </a:extLst>
              </a:tr>
              <a:tr h="1254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ymphocytes </a:t>
                      </a: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GB" sz="120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</a:t>
                      </a:r>
                      <a:r>
                        <a:rPr lang="en-GB" sz="1200" baseline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x </a:t>
                      </a:r>
                      <a:r>
                        <a:rPr lang="en-GB" sz="120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r>
                        <a:rPr lang="en-GB" sz="1200" baseline="3000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</a:t>
                      </a:r>
                      <a:r>
                        <a:rPr lang="en-GB" sz="120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L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.78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4-1785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</a:t>
                      </a: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2842564004"/>
                  </a:ext>
                </a:extLst>
              </a:tr>
              <a:tr h="759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mily history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86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7-260.1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64</a:t>
                      </a: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5270202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241236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7E1A9EC-469A-4064-AF59-667ABB610B6E}"/>
              </a:ext>
            </a:extLst>
          </p:cNvPr>
          <p:cNvSpPr txBox="1"/>
          <p:nvPr/>
        </p:nvSpPr>
        <p:spPr>
          <a:xfrm>
            <a:off x="143733" y="11804"/>
            <a:ext cx="3364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31"/>
            <a:r>
              <a:rPr lang="en-GB" b="1" dirty="0" smtClean="0">
                <a:solidFill>
                  <a:prstClr val="black"/>
                </a:solidFill>
                <a:latin typeface="Calibri" panose="020F0502020204030204"/>
              </a:rPr>
              <a:t>S fig 1</a:t>
            </a:r>
            <a:endParaRPr lang="en-GB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6EEA831-2A0A-4DFE-BD8D-50BC11818120}"/>
              </a:ext>
            </a:extLst>
          </p:cNvPr>
          <p:cNvSpPr txBox="1"/>
          <p:nvPr/>
        </p:nvSpPr>
        <p:spPr>
          <a:xfrm>
            <a:off x="1180793" y="38544"/>
            <a:ext cx="1857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A) </a:t>
            </a:r>
            <a:r>
              <a:rPr lang="en-GB" sz="1400" dirty="0"/>
              <a:t>Lymphocyte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C076E4E-B151-4DC0-BC89-93898A2719C7}"/>
              </a:ext>
            </a:extLst>
          </p:cNvPr>
          <p:cNvSpPr txBox="1"/>
          <p:nvPr/>
        </p:nvSpPr>
        <p:spPr>
          <a:xfrm>
            <a:off x="4479543" y="34792"/>
            <a:ext cx="1651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C) </a:t>
            </a:r>
            <a:r>
              <a:rPr lang="en-GB" sz="1400" dirty="0"/>
              <a:t>Live CD3+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842BC7C-83DA-4E64-AB86-59EFB11C2D64}"/>
              </a:ext>
            </a:extLst>
          </p:cNvPr>
          <p:cNvSpPr txBox="1"/>
          <p:nvPr/>
        </p:nvSpPr>
        <p:spPr>
          <a:xfrm>
            <a:off x="2895407" y="31673"/>
            <a:ext cx="11708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B) </a:t>
            </a:r>
            <a:r>
              <a:rPr lang="en-GB" sz="1400" dirty="0"/>
              <a:t>Singlet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092D188-86CC-4FC4-A415-E1A2068FA02C}"/>
              </a:ext>
            </a:extLst>
          </p:cNvPr>
          <p:cNvSpPr txBox="1"/>
          <p:nvPr/>
        </p:nvSpPr>
        <p:spPr>
          <a:xfrm>
            <a:off x="2779181" y="1806945"/>
            <a:ext cx="20577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D</a:t>
            </a:r>
            <a:r>
              <a:rPr lang="en-GB" sz="1400" b="1" dirty="0" smtClean="0"/>
              <a:t>) </a:t>
            </a:r>
            <a:r>
              <a:rPr lang="en-GB" sz="1400" dirty="0" smtClean="0"/>
              <a:t>CD4+ </a:t>
            </a:r>
          </a:p>
          <a:p>
            <a:r>
              <a:rPr lang="en-GB" sz="1400" dirty="0" smtClean="0"/>
              <a:t>and CD8</a:t>
            </a:r>
            <a:r>
              <a:rPr lang="en-GB" sz="1400" dirty="0"/>
              <a:t>+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503C971-9077-40C7-9172-7FEE7F97C6D0}"/>
              </a:ext>
            </a:extLst>
          </p:cNvPr>
          <p:cNvSpPr txBox="1"/>
          <p:nvPr/>
        </p:nvSpPr>
        <p:spPr>
          <a:xfrm>
            <a:off x="589272" y="3388796"/>
            <a:ext cx="21457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</a:t>
            </a:r>
            <a:r>
              <a:rPr lang="en-GB" sz="1400" b="1" dirty="0" smtClean="0"/>
              <a:t>E) </a:t>
            </a:r>
            <a:r>
              <a:rPr lang="en-GB" sz="1400" dirty="0" smtClean="0"/>
              <a:t>CD4+CCR4+CD26-</a:t>
            </a:r>
          </a:p>
          <a:p>
            <a:r>
              <a:rPr lang="en-GB" sz="1400" dirty="0" smtClean="0"/>
              <a:t>and ‘other’ CD4+ </a:t>
            </a:r>
            <a:endParaRPr lang="en-GB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7D14930-055A-4B00-9172-2C390458D8AC}"/>
              </a:ext>
            </a:extLst>
          </p:cNvPr>
          <p:cNvSpPr txBox="1"/>
          <p:nvPr/>
        </p:nvSpPr>
        <p:spPr>
          <a:xfrm>
            <a:off x="340174" y="8063054"/>
            <a:ext cx="604479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/>
              <a:t>Supplementary </a:t>
            </a:r>
            <a:r>
              <a:rPr lang="en-GB" sz="1050" b="1" dirty="0" smtClean="0"/>
              <a:t>Fig. </a:t>
            </a:r>
            <a:r>
              <a:rPr lang="en-GB" sz="1050" b="1" dirty="0" smtClean="0"/>
              <a:t>1. </a:t>
            </a:r>
            <a:r>
              <a:rPr lang="en-GB" sz="1050" b="1" dirty="0"/>
              <a:t>Gating strategy</a:t>
            </a:r>
            <a:r>
              <a:rPr lang="en-GB" sz="1050" dirty="0"/>
              <a:t>. L</a:t>
            </a:r>
            <a:r>
              <a:rPr lang="en-GB" sz="1050" dirty="0" smtClean="0"/>
              <a:t>ymphocytes were gated on the basis of forward and side scatter (A</a:t>
            </a:r>
            <a:r>
              <a:rPr lang="en-GB" sz="1050" dirty="0"/>
              <a:t>), followed by singlets (B), live CD3+ cells (C), CD4+ </a:t>
            </a:r>
            <a:r>
              <a:rPr lang="en-GB" sz="1050" dirty="0" smtClean="0"/>
              <a:t>or </a:t>
            </a:r>
            <a:r>
              <a:rPr lang="en-GB" sz="1050" dirty="0"/>
              <a:t>CD8+ </a:t>
            </a:r>
            <a:r>
              <a:rPr lang="en-GB" sz="1050" dirty="0" smtClean="0"/>
              <a:t>cells (D), CD4+CCR4+CD26- and ‘other’ CD4+ </a:t>
            </a:r>
            <a:r>
              <a:rPr lang="en-GB" sz="1050" dirty="0"/>
              <a:t>cells (E) </a:t>
            </a:r>
            <a:r>
              <a:rPr lang="en-GB" sz="1050" dirty="0" smtClean="0"/>
              <a:t>or </a:t>
            </a:r>
            <a:r>
              <a:rPr lang="en-GB" sz="1050" dirty="0"/>
              <a:t>CD8+CCR4+CD26- cells </a:t>
            </a:r>
            <a:r>
              <a:rPr lang="en-GB" sz="1050" dirty="0" smtClean="0"/>
              <a:t>and ‘other’ CD8+ cells (F</a:t>
            </a:r>
            <a:r>
              <a:rPr lang="en-GB" sz="1050" dirty="0"/>
              <a:t>). </a:t>
            </a:r>
            <a:r>
              <a:rPr lang="en-GB" sz="1050" dirty="0" smtClean="0"/>
              <a:t>The frequencies of CD4+CCR4+CD26- and CD8+CCR4+CD26- cells expressing each TCR </a:t>
            </a:r>
            <a:r>
              <a:rPr lang="en-GB" sz="1050" dirty="0"/>
              <a:t>v</a:t>
            </a:r>
            <a:r>
              <a:rPr lang="el-GR" sz="1050" dirty="0"/>
              <a:t>β</a:t>
            </a:r>
            <a:r>
              <a:rPr lang="en-GB" sz="1050" dirty="0"/>
              <a:t> </a:t>
            </a:r>
            <a:r>
              <a:rPr lang="en-GB" sz="1050" dirty="0" smtClean="0"/>
              <a:t>subunit were quantified </a:t>
            </a:r>
            <a:r>
              <a:rPr lang="en-GB" sz="1050" dirty="0"/>
              <a:t>(G,H,I,J</a:t>
            </a:r>
            <a:r>
              <a:rPr lang="en-GB" sz="1050" dirty="0" smtClean="0"/>
              <a:t>) and used to compute the oligoclonality index (OCI-flow) of CCR4+CD26- cells. </a:t>
            </a:r>
            <a:r>
              <a:rPr lang="en-GB" sz="1050" dirty="0"/>
              <a:t>In this example, a patient with ATL (Patient 22 from Supplementary Table 2) has a clearly expanded population in the TCR v</a:t>
            </a:r>
            <a:r>
              <a:rPr lang="el-GR" sz="1050" dirty="0"/>
              <a:t>β</a:t>
            </a:r>
            <a:r>
              <a:rPr lang="en-GB" sz="1050" dirty="0"/>
              <a:t> FITC+/PE+ window (G).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8B6CAAD-30C0-4902-AD88-D62DA700AA23}"/>
              </a:ext>
            </a:extLst>
          </p:cNvPr>
          <p:cNvSpPr txBox="1"/>
          <p:nvPr/>
        </p:nvSpPr>
        <p:spPr>
          <a:xfrm>
            <a:off x="4964048" y="3297420"/>
            <a:ext cx="21457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F) </a:t>
            </a:r>
            <a:r>
              <a:rPr lang="en-GB" sz="1400" dirty="0" smtClean="0"/>
              <a:t>CD8+CCR4+CD26-</a:t>
            </a:r>
          </a:p>
          <a:p>
            <a:r>
              <a:rPr lang="en-GB" sz="1400" dirty="0"/>
              <a:t>and ‘</a:t>
            </a:r>
            <a:r>
              <a:rPr lang="en-GB" sz="1400" dirty="0" smtClean="0"/>
              <a:t>other’ CD8+  </a:t>
            </a:r>
            <a:endParaRPr lang="en-GB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7A07AB9-748D-4887-9804-3CF29F89D9F7}"/>
              </a:ext>
            </a:extLst>
          </p:cNvPr>
          <p:cNvSpPr txBox="1"/>
          <p:nvPr/>
        </p:nvSpPr>
        <p:spPr>
          <a:xfrm>
            <a:off x="-20709" y="5821954"/>
            <a:ext cx="21044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(G) </a:t>
            </a:r>
            <a:r>
              <a:rPr lang="en-GB" sz="1400" dirty="0"/>
              <a:t>TCRV</a:t>
            </a:r>
            <a:r>
              <a:rPr lang="el-GR" sz="1400" dirty="0"/>
              <a:t>β</a:t>
            </a:r>
            <a:endParaRPr lang="en-GB" sz="1400" dirty="0"/>
          </a:p>
          <a:p>
            <a:pPr algn="ctr"/>
            <a:r>
              <a:rPr lang="en-GB" sz="1400" b="1" dirty="0" smtClean="0"/>
              <a:t> CD4+</a:t>
            </a:r>
            <a:r>
              <a:rPr lang="en-GB" sz="1400" dirty="0" smtClean="0"/>
              <a:t>CCR4+CD26-</a:t>
            </a:r>
            <a:endParaRPr lang="en-GB"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61A8021-8965-4672-9584-94F9D612B1BF}"/>
              </a:ext>
            </a:extLst>
          </p:cNvPr>
          <p:cNvSpPr txBox="1"/>
          <p:nvPr/>
        </p:nvSpPr>
        <p:spPr>
          <a:xfrm>
            <a:off x="1782991" y="5845783"/>
            <a:ext cx="17806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(H) </a:t>
            </a:r>
            <a:r>
              <a:rPr lang="en-GB" sz="1400" dirty="0"/>
              <a:t>TCRV</a:t>
            </a:r>
            <a:r>
              <a:rPr lang="el-GR" sz="1400" dirty="0"/>
              <a:t>β</a:t>
            </a:r>
            <a:endParaRPr lang="en-GB" sz="1400" dirty="0"/>
          </a:p>
          <a:p>
            <a:pPr algn="ctr"/>
            <a:r>
              <a:rPr lang="en-GB" sz="1400" b="1" dirty="0" smtClean="0"/>
              <a:t>Other </a:t>
            </a:r>
            <a:r>
              <a:rPr lang="en-GB" sz="1400" b="1" dirty="0"/>
              <a:t>CD4</a:t>
            </a:r>
            <a:r>
              <a:rPr lang="en-GB" sz="1400" b="1" dirty="0" smtClean="0"/>
              <a:t>+</a:t>
            </a:r>
            <a:endParaRPr lang="en-GB" sz="14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546D1A1-684F-4B35-B294-BC971E392AD7}"/>
              </a:ext>
            </a:extLst>
          </p:cNvPr>
          <p:cNvSpPr txBox="1"/>
          <p:nvPr/>
        </p:nvSpPr>
        <p:spPr>
          <a:xfrm>
            <a:off x="3375920" y="5842885"/>
            <a:ext cx="20578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(I) </a:t>
            </a:r>
            <a:r>
              <a:rPr lang="en-GB" sz="1400" dirty="0"/>
              <a:t>TCRV</a:t>
            </a:r>
            <a:r>
              <a:rPr lang="el-GR" sz="1400" dirty="0"/>
              <a:t>β</a:t>
            </a:r>
            <a:endParaRPr lang="en-GB" sz="1400" dirty="0"/>
          </a:p>
          <a:p>
            <a:pPr algn="ctr"/>
            <a:r>
              <a:rPr lang="en-GB" sz="1400" b="1" dirty="0" smtClean="0"/>
              <a:t>CD8+CCR4+CD26-</a:t>
            </a:r>
            <a:endParaRPr lang="en-GB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635C201-15AB-4572-8C24-333BAEEBCEBA}"/>
              </a:ext>
            </a:extLst>
          </p:cNvPr>
          <p:cNvSpPr txBox="1"/>
          <p:nvPr/>
        </p:nvSpPr>
        <p:spPr>
          <a:xfrm>
            <a:off x="5433815" y="5821027"/>
            <a:ext cx="23870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J) </a:t>
            </a:r>
            <a:r>
              <a:rPr lang="en-GB" sz="1400" dirty="0"/>
              <a:t>TCRV</a:t>
            </a:r>
            <a:r>
              <a:rPr lang="el-GR" sz="1400" dirty="0"/>
              <a:t>β</a:t>
            </a:r>
            <a:endParaRPr lang="en-GB" sz="1400" dirty="0"/>
          </a:p>
          <a:p>
            <a:r>
              <a:rPr lang="en-GB" sz="1400" b="1" dirty="0" smtClean="0"/>
              <a:t>Other CD8+</a:t>
            </a:r>
            <a:endParaRPr lang="en-GB" sz="1400" dirty="0"/>
          </a:p>
        </p:txBody>
      </p:sp>
      <p:pic>
        <p:nvPicPr>
          <p:cNvPr id="11273" name="Picture 11272">
            <a:extLst>
              <a:ext uri="{FF2B5EF4-FFF2-40B4-BE49-F238E27FC236}">
                <a16:creationId xmlns:a16="http://schemas.microsoft.com/office/drawing/2014/main" id="{7DBCD340-5E2A-4D3F-A212-1BD1D5D766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0260" y="327659"/>
            <a:ext cx="1582522" cy="1440000"/>
          </a:xfrm>
          <a:prstGeom prst="rect">
            <a:avLst/>
          </a:prstGeom>
        </p:spPr>
      </p:pic>
      <p:pic>
        <p:nvPicPr>
          <p:cNvPr id="11274" name="Picture 11273">
            <a:extLst>
              <a:ext uri="{FF2B5EF4-FFF2-40B4-BE49-F238E27FC236}">
                <a16:creationId xmlns:a16="http://schemas.microsoft.com/office/drawing/2014/main" id="{F529A228-F049-40BE-803A-A48F3F3382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49392" y="314172"/>
            <a:ext cx="1556283" cy="1440000"/>
          </a:xfrm>
          <a:prstGeom prst="rect">
            <a:avLst/>
          </a:prstGeom>
        </p:spPr>
      </p:pic>
      <p:pic>
        <p:nvPicPr>
          <p:cNvPr id="11275" name="Picture 11274">
            <a:extLst>
              <a:ext uri="{FF2B5EF4-FFF2-40B4-BE49-F238E27FC236}">
                <a16:creationId xmlns:a16="http://schemas.microsoft.com/office/drawing/2014/main" id="{4EEE6C6E-C09A-4DE5-A1D3-B7150E6C61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2992" y="2243273"/>
            <a:ext cx="1556283" cy="1440000"/>
          </a:xfrm>
          <a:prstGeom prst="rect">
            <a:avLst/>
          </a:prstGeom>
        </p:spPr>
      </p:pic>
      <p:pic>
        <p:nvPicPr>
          <p:cNvPr id="11276" name="Picture 11275">
            <a:extLst>
              <a:ext uri="{FF2B5EF4-FFF2-40B4-BE49-F238E27FC236}">
                <a16:creationId xmlns:a16="http://schemas.microsoft.com/office/drawing/2014/main" id="{D2556E2B-4F19-4370-B711-A67558AB4B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1637" y="3888243"/>
            <a:ext cx="1556283" cy="1440000"/>
          </a:xfrm>
          <a:prstGeom prst="rect">
            <a:avLst/>
          </a:prstGeom>
        </p:spPr>
      </p:pic>
      <p:pic>
        <p:nvPicPr>
          <p:cNvPr id="11277" name="Picture 11276">
            <a:extLst>
              <a:ext uri="{FF2B5EF4-FFF2-40B4-BE49-F238E27FC236}">
                <a16:creationId xmlns:a16="http://schemas.microsoft.com/office/drawing/2014/main" id="{23B3CC51-D07A-4F7C-A119-8CE9D96D58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60334" y="3910285"/>
            <a:ext cx="1556283" cy="1440000"/>
          </a:xfrm>
          <a:prstGeom prst="rect">
            <a:avLst/>
          </a:prstGeom>
        </p:spPr>
      </p:pic>
      <p:pic>
        <p:nvPicPr>
          <p:cNvPr id="11278" name="Picture 11277">
            <a:extLst>
              <a:ext uri="{FF2B5EF4-FFF2-40B4-BE49-F238E27FC236}">
                <a16:creationId xmlns:a16="http://schemas.microsoft.com/office/drawing/2014/main" id="{DB358F7F-1E11-4B07-850A-E2A2B8B853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8755" y="318997"/>
            <a:ext cx="1582522" cy="1440000"/>
          </a:xfrm>
          <a:prstGeom prst="rect">
            <a:avLst/>
          </a:prstGeom>
        </p:spPr>
      </p:pic>
      <p:pic>
        <p:nvPicPr>
          <p:cNvPr id="11281" name="Picture 11280">
            <a:extLst>
              <a:ext uri="{FF2B5EF4-FFF2-40B4-BE49-F238E27FC236}">
                <a16:creationId xmlns:a16="http://schemas.microsoft.com/office/drawing/2014/main" id="{D1536E0B-45FE-43A2-A72B-7FA099D0DEE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00424" y="6418084"/>
            <a:ext cx="1556283" cy="1440000"/>
          </a:xfrm>
          <a:prstGeom prst="rect">
            <a:avLst/>
          </a:prstGeom>
        </p:spPr>
      </p:pic>
      <p:pic>
        <p:nvPicPr>
          <p:cNvPr id="11282" name="Picture 11281">
            <a:extLst>
              <a:ext uri="{FF2B5EF4-FFF2-40B4-BE49-F238E27FC236}">
                <a16:creationId xmlns:a16="http://schemas.microsoft.com/office/drawing/2014/main" id="{A6C98151-52D8-45F3-828E-9216F86F108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3733" y="6418084"/>
            <a:ext cx="1556283" cy="1440000"/>
          </a:xfrm>
          <a:prstGeom prst="rect">
            <a:avLst/>
          </a:prstGeom>
        </p:spPr>
      </p:pic>
      <p:pic>
        <p:nvPicPr>
          <p:cNvPr id="11283" name="Picture 11282">
            <a:extLst>
              <a:ext uri="{FF2B5EF4-FFF2-40B4-BE49-F238E27FC236}">
                <a16:creationId xmlns:a16="http://schemas.microsoft.com/office/drawing/2014/main" id="{CA6B9517-2B9A-4FD4-BB49-0C01B655BEF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80474" y="6424955"/>
            <a:ext cx="1556283" cy="1440000"/>
          </a:xfrm>
          <a:prstGeom prst="rect">
            <a:avLst/>
          </a:prstGeom>
        </p:spPr>
      </p:pic>
      <p:pic>
        <p:nvPicPr>
          <p:cNvPr id="11284" name="Picture 11283">
            <a:extLst>
              <a:ext uri="{FF2B5EF4-FFF2-40B4-BE49-F238E27FC236}">
                <a16:creationId xmlns:a16="http://schemas.microsoft.com/office/drawing/2014/main" id="{E76B5333-E4A3-415C-A060-FF62DC62B64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71063" y="6426150"/>
            <a:ext cx="1556283" cy="1440000"/>
          </a:xfrm>
          <a:prstGeom prst="rect">
            <a:avLst/>
          </a:prstGeom>
        </p:spPr>
      </p:pic>
      <p:cxnSp>
        <p:nvCxnSpPr>
          <p:cNvPr id="3" name="Straight Arrow Connector 2"/>
          <p:cNvCxnSpPr/>
          <p:nvPr/>
        </p:nvCxnSpPr>
        <p:spPr>
          <a:xfrm flipH="1">
            <a:off x="2779181" y="3287032"/>
            <a:ext cx="557576" cy="5693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4069275" y="2805779"/>
            <a:ext cx="589512" cy="10294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057969" y="2805779"/>
            <a:ext cx="101130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endCxn id="38" idx="0"/>
          </p:cNvCxnSpPr>
          <p:nvPr/>
        </p:nvCxnSpPr>
        <p:spPr>
          <a:xfrm flipH="1">
            <a:off x="1031535" y="4847422"/>
            <a:ext cx="1579463" cy="9745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3163016" y="4481094"/>
            <a:ext cx="0" cy="12755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2723268" y="4481094"/>
            <a:ext cx="439748" cy="51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H="1">
            <a:off x="4364511" y="4957590"/>
            <a:ext cx="706552" cy="7922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5970483" y="4380104"/>
            <a:ext cx="0" cy="12755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305358" y="4380104"/>
            <a:ext cx="66512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949986" y="1068685"/>
            <a:ext cx="773282" cy="109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3631585" y="1089428"/>
            <a:ext cx="773282" cy="109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H="1">
            <a:off x="4018226" y="1415141"/>
            <a:ext cx="935558" cy="4602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201440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AF777-249B-4CFA-ACC9-E9B46037D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4162" y="119136"/>
            <a:ext cx="5589676" cy="340477"/>
          </a:xfrm>
        </p:spPr>
        <p:txBody>
          <a:bodyPr>
            <a:normAutofit/>
          </a:bodyPr>
          <a:lstStyle/>
          <a:p>
            <a:r>
              <a:rPr lang="en-GB" sz="1800" b="1" dirty="0" smtClean="0">
                <a:latin typeface="+mn-lt"/>
              </a:rPr>
              <a:t>S fig 2</a:t>
            </a:r>
            <a:endParaRPr lang="en-GB" sz="1800" b="1" dirty="0">
              <a:latin typeface="+mn-lt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D968F5-BA62-411D-8249-2EBBD3A6E791}"/>
              </a:ext>
            </a:extLst>
          </p:cNvPr>
          <p:cNvSpPr txBox="1"/>
          <p:nvPr/>
        </p:nvSpPr>
        <p:spPr>
          <a:xfrm>
            <a:off x="340190" y="2289944"/>
            <a:ext cx="1715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(C</a:t>
            </a:r>
            <a:r>
              <a:rPr lang="en-GB" sz="1400" b="1" dirty="0"/>
              <a:t>) </a:t>
            </a:r>
            <a:r>
              <a:rPr lang="en-GB" sz="1400" dirty="0"/>
              <a:t>Other CD4+</a:t>
            </a: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276BE1C9-ED3B-4829-81CE-DE3FDFD017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1434453"/>
              </p:ext>
            </p:extLst>
          </p:nvPr>
        </p:nvGraphicFramePr>
        <p:xfrm>
          <a:off x="2227558" y="2322607"/>
          <a:ext cx="2575794" cy="222885"/>
        </p:xfrm>
        <a:graphic>
          <a:graphicData uri="http://schemas.openxmlformats.org/drawingml/2006/table">
            <a:tbl>
              <a:tblPr/>
              <a:tblGrid>
                <a:gridCol w="2575794">
                  <a:extLst>
                    <a:ext uri="{9D8B030D-6E8A-4147-A177-3AD203B41FA5}">
                      <a16:colId xmlns:a16="http://schemas.microsoft.com/office/drawing/2014/main" val="303679817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b="1" i="0" u="none" strike="noStrike" dirty="0" smtClean="0">
                          <a:effectLst/>
                          <a:latin typeface="+mn-lt"/>
                        </a:rPr>
                        <a:t>(D</a:t>
                      </a:r>
                      <a:r>
                        <a:rPr lang="en-GB" sz="1400" b="1" i="0" u="none" strike="noStrike" dirty="0">
                          <a:effectLst/>
                          <a:latin typeface="+mn-lt"/>
                        </a:rPr>
                        <a:t>) </a:t>
                      </a:r>
                      <a:r>
                        <a:rPr lang="en-GB" sz="1400" b="0" i="0" u="none" strike="noStrike" dirty="0" smtClean="0">
                          <a:effectLst/>
                          <a:latin typeface="+mn-lt"/>
                        </a:rPr>
                        <a:t>CD4+CCR4+CD26-V</a:t>
                      </a:r>
                      <a:r>
                        <a:rPr lang="el-GR" sz="1400" b="0" i="0" u="none" strike="noStrike" dirty="0">
                          <a:effectLst/>
                          <a:latin typeface="+mn-lt"/>
                        </a:rPr>
                        <a:t>β</a:t>
                      </a:r>
                      <a:r>
                        <a:rPr lang="en-GB" sz="1400" b="0" i="0" u="none" strike="noStrike" dirty="0">
                          <a:effectLst/>
                          <a:latin typeface="+mn-lt"/>
                        </a:rPr>
                        <a:t>X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8979257"/>
                  </a:ext>
                </a:extLst>
              </a:tr>
            </a:tbl>
          </a:graphicData>
        </a:graphic>
      </p:graphicFrame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id="{D1413189-FDAA-47B3-A76A-50FB97E673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3802108"/>
              </p:ext>
            </p:extLst>
          </p:nvPr>
        </p:nvGraphicFramePr>
        <p:xfrm>
          <a:off x="4547196" y="2320714"/>
          <a:ext cx="4156125" cy="222885"/>
        </p:xfrm>
        <a:graphic>
          <a:graphicData uri="http://schemas.openxmlformats.org/drawingml/2006/table">
            <a:tbl>
              <a:tblPr/>
              <a:tblGrid>
                <a:gridCol w="4156125">
                  <a:extLst>
                    <a:ext uri="{9D8B030D-6E8A-4147-A177-3AD203B41FA5}">
                      <a16:colId xmlns:a16="http://schemas.microsoft.com/office/drawing/2014/main" val="303679817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b="1" i="0" u="none" strike="noStrike" dirty="0" smtClean="0">
                          <a:effectLst/>
                          <a:latin typeface="+mn-lt"/>
                        </a:rPr>
                        <a:t>(E</a:t>
                      </a:r>
                      <a:r>
                        <a:rPr lang="en-GB" sz="1400" b="1" i="0" u="none" strike="noStrike" dirty="0">
                          <a:effectLst/>
                          <a:latin typeface="+mn-lt"/>
                        </a:rPr>
                        <a:t>) </a:t>
                      </a:r>
                      <a:r>
                        <a:rPr lang="en-GB" sz="1400" b="0" i="0" u="none" strike="noStrike" dirty="0" smtClean="0">
                          <a:effectLst/>
                          <a:latin typeface="+mn-lt"/>
                        </a:rPr>
                        <a:t>CD4+CCR4+CD26-V</a:t>
                      </a:r>
                      <a:r>
                        <a:rPr lang="el-GR" sz="1400" b="0" i="0" u="none" strike="noStrike" dirty="0">
                          <a:effectLst/>
                          <a:latin typeface="+mn-lt"/>
                        </a:rPr>
                        <a:t>β</a:t>
                      </a:r>
                      <a:r>
                        <a:rPr lang="en-GB" sz="1400" b="0" i="0" u="none" strike="noStrike" dirty="0">
                          <a:effectLst/>
                          <a:latin typeface="+mn-lt"/>
                        </a:rPr>
                        <a:t>X+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8979257"/>
                  </a:ext>
                </a:extLst>
              </a:tr>
            </a:tbl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42242296-B79F-4E03-AE79-504907F2C79D}"/>
              </a:ext>
            </a:extLst>
          </p:cNvPr>
          <p:cNvSpPr txBox="1"/>
          <p:nvPr/>
        </p:nvSpPr>
        <p:spPr>
          <a:xfrm>
            <a:off x="1751503" y="384407"/>
            <a:ext cx="18840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A) </a:t>
            </a:r>
            <a:r>
              <a:rPr lang="en-GB" sz="1400" dirty="0"/>
              <a:t>CCR4+CD26-</a:t>
            </a:r>
          </a:p>
          <a:p>
            <a:endParaRPr lang="en-GB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3491357-D844-4AD4-B66B-9A7D43F361E5}"/>
              </a:ext>
            </a:extLst>
          </p:cNvPr>
          <p:cNvSpPr txBox="1"/>
          <p:nvPr/>
        </p:nvSpPr>
        <p:spPr>
          <a:xfrm>
            <a:off x="3587273" y="371137"/>
            <a:ext cx="1970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(B</a:t>
            </a:r>
            <a:r>
              <a:rPr lang="en-GB" sz="1400" b="1" dirty="0" smtClean="0"/>
              <a:t>) </a:t>
            </a:r>
            <a:r>
              <a:rPr lang="en-GB" sz="1400" dirty="0" smtClean="0"/>
              <a:t>TCRV</a:t>
            </a:r>
            <a:r>
              <a:rPr lang="el-GR" sz="1400" dirty="0" smtClean="0"/>
              <a:t>β</a:t>
            </a:r>
            <a:r>
              <a:rPr lang="en-GB" sz="1400" dirty="0" smtClean="0"/>
              <a:t>X</a:t>
            </a:r>
            <a:endParaRPr lang="en-GB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3C0967C-9CB4-4FC0-95C8-F59EE23DF5AE}"/>
              </a:ext>
            </a:extLst>
          </p:cNvPr>
          <p:cNvSpPr txBox="1"/>
          <p:nvPr/>
        </p:nvSpPr>
        <p:spPr>
          <a:xfrm>
            <a:off x="331003" y="4195030"/>
            <a:ext cx="1715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(F</a:t>
            </a:r>
            <a:r>
              <a:rPr lang="en-GB" sz="1400" b="1" dirty="0"/>
              <a:t>) </a:t>
            </a:r>
            <a:r>
              <a:rPr lang="en-GB" sz="1400" dirty="0"/>
              <a:t>Other CD4+</a:t>
            </a:r>
          </a:p>
        </p:txBody>
      </p:sp>
      <p:graphicFrame>
        <p:nvGraphicFramePr>
          <p:cNvPr id="41" name="Table 40">
            <a:extLst>
              <a:ext uri="{FF2B5EF4-FFF2-40B4-BE49-F238E27FC236}">
                <a16:creationId xmlns:a16="http://schemas.microsoft.com/office/drawing/2014/main" id="{E21DC404-43BE-437C-A69A-7019496614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583878"/>
              </p:ext>
            </p:extLst>
          </p:nvPr>
        </p:nvGraphicFramePr>
        <p:xfrm>
          <a:off x="2181120" y="4237477"/>
          <a:ext cx="2493722" cy="222885"/>
        </p:xfrm>
        <a:graphic>
          <a:graphicData uri="http://schemas.openxmlformats.org/drawingml/2006/table">
            <a:tbl>
              <a:tblPr/>
              <a:tblGrid>
                <a:gridCol w="2493722">
                  <a:extLst>
                    <a:ext uri="{9D8B030D-6E8A-4147-A177-3AD203B41FA5}">
                      <a16:colId xmlns:a16="http://schemas.microsoft.com/office/drawing/2014/main" val="303679817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b="1" i="0" u="none" strike="noStrike" dirty="0" smtClean="0">
                          <a:effectLst/>
                          <a:latin typeface="+mn-lt"/>
                        </a:rPr>
                        <a:t>(G</a:t>
                      </a:r>
                      <a:r>
                        <a:rPr lang="en-GB" sz="1400" b="1" i="0" u="none" strike="noStrike" dirty="0">
                          <a:effectLst/>
                          <a:latin typeface="+mn-lt"/>
                        </a:rPr>
                        <a:t>) </a:t>
                      </a:r>
                      <a:r>
                        <a:rPr lang="en-GB" sz="1400" b="0" i="0" u="none" strike="noStrike" dirty="0" smtClean="0">
                          <a:effectLst/>
                          <a:latin typeface="+mn-lt"/>
                        </a:rPr>
                        <a:t>CD4+CCR4+CD26-V</a:t>
                      </a:r>
                      <a:r>
                        <a:rPr lang="el-GR" sz="1400" b="0" i="0" u="none" strike="noStrike" dirty="0" smtClean="0">
                          <a:effectLst/>
                          <a:latin typeface="+mn-lt"/>
                        </a:rPr>
                        <a:t>β</a:t>
                      </a:r>
                      <a:r>
                        <a:rPr lang="en-GB" sz="1400" b="0" i="0" u="none" strike="noStrike" dirty="0">
                          <a:effectLst/>
                          <a:latin typeface="+mn-lt"/>
                        </a:rPr>
                        <a:t>X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8979257"/>
                  </a:ext>
                </a:extLst>
              </a:tr>
            </a:tbl>
          </a:graphicData>
        </a:graphic>
      </p:graphicFrame>
      <p:graphicFrame>
        <p:nvGraphicFramePr>
          <p:cNvPr id="43" name="Table 42">
            <a:extLst>
              <a:ext uri="{FF2B5EF4-FFF2-40B4-BE49-F238E27FC236}">
                <a16:creationId xmlns:a16="http://schemas.microsoft.com/office/drawing/2014/main" id="{C63F65C9-CA49-43D2-96CD-9205C7479F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0088832"/>
              </p:ext>
            </p:extLst>
          </p:nvPr>
        </p:nvGraphicFramePr>
        <p:xfrm>
          <a:off x="4610123" y="4253869"/>
          <a:ext cx="4030269" cy="222885"/>
        </p:xfrm>
        <a:graphic>
          <a:graphicData uri="http://schemas.openxmlformats.org/drawingml/2006/table">
            <a:tbl>
              <a:tblPr/>
              <a:tblGrid>
                <a:gridCol w="4030269">
                  <a:extLst>
                    <a:ext uri="{9D8B030D-6E8A-4147-A177-3AD203B41FA5}">
                      <a16:colId xmlns:a16="http://schemas.microsoft.com/office/drawing/2014/main" val="303679817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400" b="1" i="0" u="none" strike="noStrike" dirty="0" smtClean="0">
                          <a:effectLst/>
                          <a:latin typeface="+mn-lt"/>
                        </a:rPr>
                        <a:t>(H</a:t>
                      </a:r>
                      <a:r>
                        <a:rPr lang="en-GB" sz="1400" b="1" i="0" u="none" strike="noStrike" dirty="0">
                          <a:effectLst/>
                          <a:latin typeface="+mn-lt"/>
                        </a:rPr>
                        <a:t>) </a:t>
                      </a:r>
                      <a:r>
                        <a:rPr lang="en-GB" sz="1400" b="0" i="0" u="none" strike="noStrike" dirty="0" smtClean="0">
                          <a:effectLst/>
                          <a:latin typeface="+mn-lt"/>
                        </a:rPr>
                        <a:t>CD4+CCR4+CD26-V</a:t>
                      </a:r>
                      <a:r>
                        <a:rPr lang="el-GR" sz="1400" b="0" i="0" u="none" strike="noStrike" dirty="0">
                          <a:effectLst/>
                          <a:latin typeface="+mn-lt"/>
                        </a:rPr>
                        <a:t>β</a:t>
                      </a:r>
                      <a:r>
                        <a:rPr lang="en-GB" sz="1400" b="0" i="0" u="none" strike="noStrike" dirty="0">
                          <a:effectLst/>
                          <a:latin typeface="+mn-lt"/>
                        </a:rPr>
                        <a:t>X+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8979257"/>
                  </a:ext>
                </a:extLst>
              </a:tr>
            </a:tbl>
          </a:graphicData>
        </a:graphic>
      </p:graphicFrame>
      <p:sp>
        <p:nvSpPr>
          <p:cNvPr id="44" name="Rectangle 43">
            <a:extLst>
              <a:ext uri="{FF2B5EF4-FFF2-40B4-BE49-F238E27FC236}">
                <a16:creationId xmlns:a16="http://schemas.microsoft.com/office/drawing/2014/main" id="{3F96564D-8AB7-4180-8F80-31FA270DB725}"/>
              </a:ext>
            </a:extLst>
          </p:cNvPr>
          <p:cNvSpPr/>
          <p:nvPr/>
        </p:nvSpPr>
        <p:spPr>
          <a:xfrm>
            <a:off x="143220" y="8143374"/>
            <a:ext cx="6356732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50" b="1" dirty="0"/>
              <a:t>Supplementary </a:t>
            </a:r>
            <a:r>
              <a:rPr lang="en-GB" sz="1050" b="1" dirty="0" smtClean="0"/>
              <a:t>Fig. </a:t>
            </a:r>
            <a:r>
              <a:rPr lang="en-GB" sz="1050" b="1" dirty="0" smtClean="0"/>
              <a:t>2. </a:t>
            </a:r>
            <a:r>
              <a:rPr lang="en-GB" sz="1050" b="1" dirty="0"/>
              <a:t>Gating </a:t>
            </a:r>
            <a:r>
              <a:rPr lang="en-GB" sz="1050" b="1" dirty="0" smtClean="0"/>
              <a:t>strategy for CD7, Ki-67 and HAS-flow analysis</a:t>
            </a:r>
            <a:r>
              <a:rPr lang="en-GB" sz="1050" dirty="0" smtClean="0"/>
              <a:t>. </a:t>
            </a:r>
            <a:r>
              <a:rPr lang="en-GB" sz="1050" dirty="0"/>
              <a:t>PBMCs were gated as </a:t>
            </a:r>
            <a:r>
              <a:rPr lang="en-GB" sz="1050" dirty="0" smtClean="0"/>
              <a:t>shown in supplementary </a:t>
            </a:r>
            <a:r>
              <a:rPr lang="en-GB" sz="1050" dirty="0"/>
              <a:t>Figure 1; with CD4+ </a:t>
            </a:r>
            <a:r>
              <a:rPr lang="en-GB" sz="1050" dirty="0" smtClean="0"/>
              <a:t>cells classified as CCR4+CD26- T cells or </a:t>
            </a:r>
            <a:r>
              <a:rPr lang="en-GB" sz="1050" dirty="0"/>
              <a:t>‘Other CD4</a:t>
            </a:r>
            <a:r>
              <a:rPr lang="en-GB" sz="1050" dirty="0" smtClean="0"/>
              <a:t>+’ cells </a:t>
            </a:r>
            <a:r>
              <a:rPr lang="en-GB" sz="1050" dirty="0"/>
              <a:t>(A). </a:t>
            </a:r>
            <a:r>
              <a:rPr lang="en-GB" sz="1050" dirty="0" smtClean="0"/>
              <a:t>CD4+CCR4+CD26- cells were further gated on the basis of TCRV</a:t>
            </a:r>
            <a:r>
              <a:rPr lang="el-GR" sz="1050" dirty="0" smtClean="0"/>
              <a:t>β</a:t>
            </a:r>
            <a:r>
              <a:rPr lang="en-GB" sz="1050" dirty="0" smtClean="0"/>
              <a:t> expression into CCR4+CD26-V</a:t>
            </a:r>
            <a:r>
              <a:rPr lang="el-GR" sz="1050" dirty="0" smtClean="0"/>
              <a:t>β</a:t>
            </a:r>
            <a:r>
              <a:rPr lang="en-GB" sz="1050" dirty="0" smtClean="0"/>
              <a:t>X+ </a:t>
            </a:r>
            <a:r>
              <a:rPr lang="en-GB" sz="1050" dirty="0"/>
              <a:t>and CCR4+CD26-V</a:t>
            </a:r>
            <a:r>
              <a:rPr lang="el-GR" sz="1050" dirty="0" smtClean="0"/>
              <a:t>β</a:t>
            </a:r>
            <a:r>
              <a:rPr lang="en-GB" sz="1050" dirty="0" smtClean="0"/>
              <a:t>X- cells (B).Within these subsets, the frequencies of cells expressing CD7 (</a:t>
            </a:r>
            <a:r>
              <a:rPr lang="en-GB" sz="1050" dirty="0"/>
              <a:t>C, D, E) and </a:t>
            </a:r>
            <a:r>
              <a:rPr lang="en-GB" sz="1050" dirty="0" smtClean="0"/>
              <a:t>Ki-67 (F</a:t>
            </a:r>
            <a:r>
              <a:rPr lang="en-GB" sz="1050" dirty="0"/>
              <a:t>, G, H</a:t>
            </a:r>
            <a:r>
              <a:rPr lang="en-GB" sz="1050" dirty="0" smtClean="0"/>
              <a:t>) were quantified. CD4+CCR4+CD26- cells which were negative </a:t>
            </a:r>
            <a:r>
              <a:rPr lang="en-GB" sz="1050" dirty="0"/>
              <a:t>for CD7 (%N) </a:t>
            </a:r>
            <a:r>
              <a:rPr lang="en-GB" sz="1050" dirty="0" smtClean="0"/>
              <a:t>or CD7dim </a:t>
            </a:r>
            <a:r>
              <a:rPr lang="en-GB" sz="1050" dirty="0"/>
              <a:t>(%D) (I</a:t>
            </a:r>
            <a:r>
              <a:rPr lang="en-GB" sz="1050" dirty="0" smtClean="0"/>
              <a:t>) were identified in a </a:t>
            </a:r>
            <a:r>
              <a:rPr lang="en-GB" sz="1050" dirty="0"/>
              <a:t>gating </a:t>
            </a:r>
            <a:r>
              <a:rPr lang="en-GB" sz="1050" dirty="0" smtClean="0"/>
              <a:t>strategy derived from Kobayashi </a:t>
            </a:r>
            <a:r>
              <a:rPr lang="en-GB" sz="1050" dirty="0"/>
              <a:t>and colleagues (27</a:t>
            </a:r>
            <a:r>
              <a:rPr lang="en-GB" sz="1050" dirty="0" smtClean="0"/>
              <a:t>). </a:t>
            </a:r>
            <a:endParaRPr lang="en-GB" sz="1050" dirty="0"/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B78D761C-DBF1-4855-B768-3F909297A0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2583" y="698917"/>
            <a:ext cx="1556283" cy="1440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CD825689-48B2-46CD-A444-BB09B6548B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1003" y="2656748"/>
            <a:ext cx="1556283" cy="14400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A24C8595-4D80-4B94-B2F6-C0FE941166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70395" y="2667153"/>
            <a:ext cx="1556283" cy="14400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34EAFA9C-0FAD-4D9C-8AD3-04CA4DF680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67832" y="698917"/>
            <a:ext cx="1556283" cy="14400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F9743995-714E-40B8-BC97-B51FF75055E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4842" y="2667153"/>
            <a:ext cx="1556283" cy="1440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3BD1ED65-AE06-4A3E-A1D7-85D1C05627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0190" y="4530718"/>
            <a:ext cx="1556283" cy="14400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6DC84686-0784-48F9-A25D-DFD08442A61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70395" y="4572000"/>
            <a:ext cx="1556283" cy="14400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C6B5E65D-9E93-4456-8D4D-EA24A7ED232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06982" y="4581005"/>
            <a:ext cx="1556283" cy="1440000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EFDA87B2-D75F-4A8F-B2CE-F7833082EC8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70394" y="6513490"/>
            <a:ext cx="1556283" cy="1440000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936E77B3-24D8-4E4F-8C24-CBB80F31F9A5}"/>
              </a:ext>
            </a:extLst>
          </p:cNvPr>
          <p:cNvSpPr txBox="1"/>
          <p:nvPr/>
        </p:nvSpPr>
        <p:spPr>
          <a:xfrm>
            <a:off x="2491966" y="6205713"/>
            <a:ext cx="2311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(I</a:t>
            </a:r>
            <a:r>
              <a:rPr lang="en-GB" sz="1400" b="1" dirty="0"/>
              <a:t>)</a:t>
            </a:r>
            <a:r>
              <a:rPr lang="en-GB" sz="1400" dirty="0"/>
              <a:t> </a:t>
            </a:r>
            <a:r>
              <a:rPr lang="en-GB" sz="1400" dirty="0" smtClean="0"/>
              <a:t>CD7 D and N gating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9577098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AF777-249B-4CFA-ACC9-E9B46037DAB5}"/>
              </a:ext>
            </a:extLst>
          </p:cNvPr>
          <p:cNvSpPr txBox="1">
            <a:spLocks/>
          </p:cNvSpPr>
          <p:nvPr/>
        </p:nvSpPr>
        <p:spPr>
          <a:xfrm>
            <a:off x="634162" y="119136"/>
            <a:ext cx="5589676" cy="340477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33047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4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800" b="1" dirty="0" smtClean="0">
                <a:latin typeface="+mn-lt"/>
              </a:rPr>
              <a:t>S fig 3</a:t>
            </a:r>
            <a:endParaRPr lang="en-GB" sz="1800" b="1" dirty="0">
              <a:latin typeface="+mn-lt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4006483"/>
              </p:ext>
            </p:extLst>
          </p:nvPr>
        </p:nvGraphicFramePr>
        <p:xfrm>
          <a:off x="1656949" y="842982"/>
          <a:ext cx="2905125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3" name="Prism 9" r:id="rId3" imgW="2904495" imgH="2698634" progId="Prism9.Document">
                  <p:embed/>
                </p:oleObj>
              </mc:Choice>
              <mc:Fallback>
                <p:oleObj name="Prism 9" r:id="rId3" imgW="2904495" imgH="269863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56949" y="842982"/>
                        <a:ext cx="2905125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3F96564D-8AB7-4180-8F80-31FA270DB725}"/>
              </a:ext>
            </a:extLst>
          </p:cNvPr>
          <p:cNvSpPr/>
          <p:nvPr/>
        </p:nvSpPr>
        <p:spPr>
          <a:xfrm>
            <a:off x="354985" y="5731868"/>
            <a:ext cx="614803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/>
              <a:t>Supplementary </a:t>
            </a:r>
            <a:r>
              <a:rPr lang="en-GB" sz="1100" b="1" dirty="0" smtClean="0"/>
              <a:t>Fig. 3. </a:t>
            </a:r>
            <a:r>
              <a:rPr lang="en-GB" sz="1100" b="1" dirty="0" smtClean="0"/>
              <a:t>Reproducibility of OCI-flow</a:t>
            </a:r>
            <a:r>
              <a:rPr lang="en-GB" sz="1100" dirty="0" smtClean="0"/>
              <a:t>. PBMC samples were </a:t>
            </a:r>
            <a:r>
              <a:rPr lang="en-GB" sz="1100" dirty="0" err="1" smtClean="0"/>
              <a:t>aliquoted</a:t>
            </a:r>
            <a:r>
              <a:rPr lang="en-GB" sz="1100" dirty="0" smtClean="0"/>
              <a:t> and cryopreserved. Samples were assayed in two independent runs and the OCI-flow was plotted. A simple linear regression line was plotted. Inset table shows raw data, mean, standard deviation (</a:t>
            </a:r>
            <a:r>
              <a:rPr lang="en-GB" sz="1100" dirty="0" err="1" smtClean="0"/>
              <a:t>StDev</a:t>
            </a:r>
            <a:r>
              <a:rPr lang="en-GB" sz="1100" dirty="0" smtClean="0"/>
              <a:t>) and % Coefficient of variation (% CV), calculated as follows: (</a:t>
            </a:r>
            <a:r>
              <a:rPr lang="en-GB" sz="1100" dirty="0" err="1" smtClean="0"/>
              <a:t>StDev</a:t>
            </a:r>
            <a:r>
              <a:rPr lang="en-GB" sz="1100" dirty="0" smtClean="0"/>
              <a:t>/mean)*100.</a:t>
            </a:r>
            <a:endParaRPr lang="en-GB" sz="1100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4125194"/>
              </p:ext>
            </p:extLst>
          </p:nvPr>
        </p:nvGraphicFramePr>
        <p:xfrm>
          <a:off x="1143000" y="3779550"/>
          <a:ext cx="4572000" cy="17145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val="233111486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06447138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35801250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971203356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13382026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4098833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amp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plicate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plicate 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Mea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err="1" smtClean="0">
                          <a:effectLst/>
                        </a:rPr>
                        <a:t>StDev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%CV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385532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2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2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2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0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56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62135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4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2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3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.56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9223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72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72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7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0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57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980482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8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9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0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.2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83123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5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2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6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.6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87165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9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0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7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152231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9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9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9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0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30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809517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85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85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85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00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3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903868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3343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8AA01F4-3C63-43E7-9D69-6DE45F65A2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9334346"/>
              </p:ext>
            </p:extLst>
          </p:nvPr>
        </p:nvGraphicFramePr>
        <p:xfrm>
          <a:off x="2454275" y="692026"/>
          <a:ext cx="2357438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4" name="Prism 9" r:id="rId3" imgW="2945550" imgH="2698634" progId="Prism9.Document">
                  <p:embed/>
                </p:oleObj>
              </mc:Choice>
              <mc:Fallback>
                <p:oleObj name="Prism 9" r:id="rId3" imgW="2945550" imgH="2698634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8AA01F4-3C63-43E7-9D69-6DE45F65A2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54275" y="692026"/>
                        <a:ext cx="2357438" cy="2157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AA4ADB5-F14A-4ED6-B2B0-6F9A0858B19A}"/>
              </a:ext>
            </a:extLst>
          </p:cNvPr>
          <p:cNvSpPr txBox="1"/>
          <p:nvPr/>
        </p:nvSpPr>
        <p:spPr>
          <a:xfrm>
            <a:off x="151595" y="110004"/>
            <a:ext cx="1753109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5" b="1" dirty="0"/>
              <a:t>Supplementary Figure </a:t>
            </a:r>
            <a:r>
              <a:rPr lang="en-GB" sz="1245" b="1" dirty="0" smtClean="0"/>
              <a:t>4</a:t>
            </a:r>
            <a:endParaRPr lang="en-GB" sz="1245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EC3F57-DAF9-46A5-98F7-387D70876E83}"/>
              </a:ext>
            </a:extLst>
          </p:cNvPr>
          <p:cNvSpPr txBox="1"/>
          <p:nvPr/>
        </p:nvSpPr>
        <p:spPr>
          <a:xfrm>
            <a:off x="850623" y="445632"/>
            <a:ext cx="1732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(A) Training </a:t>
            </a:r>
            <a:r>
              <a:rPr lang="en-GB" sz="1200" b="1" dirty="0"/>
              <a:t>cohor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C6E3A07-623D-4F09-B7BA-EED3E780F8D1}"/>
              </a:ext>
            </a:extLst>
          </p:cNvPr>
          <p:cNvSpPr txBox="1"/>
          <p:nvPr/>
        </p:nvSpPr>
        <p:spPr>
          <a:xfrm>
            <a:off x="5260738" y="438707"/>
            <a:ext cx="1085554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5" b="1" dirty="0"/>
              <a:t>(C</a:t>
            </a:r>
            <a:r>
              <a:rPr lang="en-GB" sz="1245" b="1" dirty="0" smtClean="0"/>
              <a:t>) OCI&gt;0.770</a:t>
            </a:r>
            <a:endParaRPr lang="en-GB" sz="1245" b="1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08B21E3-D51C-44FE-B9BC-AF6A141B5A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6549399"/>
              </p:ext>
            </p:extLst>
          </p:nvPr>
        </p:nvGraphicFramePr>
        <p:xfrm>
          <a:off x="4439468" y="690439"/>
          <a:ext cx="2355850" cy="215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5" name="Prism 9" r:id="rId5" imgW="2945550" imgH="2698634" progId="Prism9.Document">
                  <p:embed/>
                </p:oleObj>
              </mc:Choice>
              <mc:Fallback>
                <p:oleObj name="Prism 9" r:id="rId5" imgW="2945550" imgH="2698634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B08B21E3-D51C-44FE-B9BC-AF6A141B5A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39468" y="690439"/>
                        <a:ext cx="2355850" cy="215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7952674-AE26-456D-A5E5-A1A6BE7BA5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1155714"/>
              </p:ext>
            </p:extLst>
          </p:nvPr>
        </p:nvGraphicFramePr>
        <p:xfrm>
          <a:off x="151595" y="690439"/>
          <a:ext cx="2354262" cy="215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" name="Prism 9" r:id="rId7" imgW="2945550" imgH="2698634" progId="Prism9.Document">
                  <p:embed/>
                </p:oleObj>
              </mc:Choice>
              <mc:Fallback>
                <p:oleObj name="Prism 9" r:id="rId7" imgW="2945550" imgH="2698634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C7952674-AE26-456D-A5E5-A1A6BE7BA5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1595" y="690439"/>
                        <a:ext cx="2354262" cy="215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44E9156-90C0-43E5-BC5A-2F613921E4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0293456"/>
              </p:ext>
            </p:extLst>
          </p:nvPr>
        </p:nvGraphicFramePr>
        <p:xfrm>
          <a:off x="3563938" y="3390453"/>
          <a:ext cx="2868612" cy="2025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7" name="Prism 9" r:id="rId9" imgW="3823561" imgH="2701515" progId="Prism9.Document">
                  <p:embed/>
                </p:oleObj>
              </mc:Choice>
              <mc:Fallback>
                <p:oleObj name="Prism 9" r:id="rId9" imgW="3823561" imgH="2701515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44E9156-90C0-43E5-BC5A-2F613921E4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63938" y="3390453"/>
                        <a:ext cx="2868612" cy="2025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BD03A0E2-3F2B-4A8F-9446-EDCC0F5CF9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5909689"/>
              </p:ext>
            </p:extLst>
          </p:nvPr>
        </p:nvGraphicFramePr>
        <p:xfrm>
          <a:off x="331745" y="3389465"/>
          <a:ext cx="2895600" cy="2024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8" name="Prism 9" r:id="rId11" imgW="3860295" imgH="2698634" progId="Prism9.Document">
                  <p:embed/>
                </p:oleObj>
              </mc:Choice>
              <mc:Fallback>
                <p:oleObj name="Prism 9" r:id="rId11" imgW="3860295" imgH="2698634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BD03A0E2-3F2B-4A8F-9446-EDCC0F5CF9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1745" y="3389465"/>
                        <a:ext cx="2895600" cy="2024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0C6E3A07-623D-4F09-B7BA-EED3E780F8D1}"/>
              </a:ext>
            </a:extLst>
          </p:cNvPr>
          <p:cNvSpPr txBox="1"/>
          <p:nvPr/>
        </p:nvSpPr>
        <p:spPr>
          <a:xfrm>
            <a:off x="3187109" y="438707"/>
            <a:ext cx="1090363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5" b="1" dirty="0"/>
              <a:t>(B</a:t>
            </a:r>
            <a:r>
              <a:rPr lang="en-GB" sz="1245" b="1" dirty="0" smtClean="0"/>
              <a:t>) OCI&lt;0.770</a:t>
            </a:r>
            <a:endParaRPr lang="en-GB" sz="1245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6E3A07-623D-4F09-B7BA-EED3E780F8D1}"/>
              </a:ext>
            </a:extLst>
          </p:cNvPr>
          <p:cNvSpPr txBox="1"/>
          <p:nvPr/>
        </p:nvSpPr>
        <p:spPr>
          <a:xfrm>
            <a:off x="331745" y="3055815"/>
            <a:ext cx="385042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5" b="1" dirty="0"/>
              <a:t>(D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6E3A07-623D-4F09-B7BA-EED3E780F8D1}"/>
              </a:ext>
            </a:extLst>
          </p:cNvPr>
          <p:cNvSpPr txBox="1"/>
          <p:nvPr/>
        </p:nvSpPr>
        <p:spPr>
          <a:xfrm>
            <a:off x="3786951" y="3055815"/>
            <a:ext cx="362600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5" b="1" dirty="0"/>
              <a:t>(E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9003" y="5835114"/>
            <a:ext cx="613999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Supplementary</a:t>
            </a:r>
            <a:r>
              <a:rPr lang="en-GB" sz="1100" b="1" dirty="0" smtClean="0"/>
              <a:t> Fig. 4. </a:t>
            </a:r>
            <a:r>
              <a:rPr lang="en-GB" sz="1100" b="1" dirty="0" smtClean="0"/>
              <a:t>CD7 downregulation and oligoclonality</a:t>
            </a:r>
          </a:p>
          <a:p>
            <a:r>
              <a:rPr lang="en-GB" sz="1100" dirty="0" smtClean="0"/>
              <a:t>% CD7 dim </a:t>
            </a:r>
            <a:r>
              <a:rPr lang="en-GB" sz="1100" dirty="0" smtClean="0"/>
              <a:t>(%D</a:t>
            </a:r>
            <a:r>
              <a:rPr lang="en-GB" sz="1100" dirty="0" smtClean="0"/>
              <a:t>) and % CD7 negative </a:t>
            </a:r>
            <a:r>
              <a:rPr lang="en-GB" sz="1100" dirty="0" smtClean="0"/>
              <a:t>(%N</a:t>
            </a:r>
            <a:r>
              <a:rPr lang="en-GB" sz="1100" dirty="0" smtClean="0"/>
              <a:t>) CCR4+CD26- cells within total CD4+ T cells in samples from (A) the training cohort (B) donors with OCI&lt;0.770 in the screening cohort (C) and donors with OCI&gt;0.770 in the </a:t>
            </a:r>
            <a:r>
              <a:rPr lang="en-GB" sz="1100" dirty="0"/>
              <a:t>screening </a:t>
            </a:r>
            <a:r>
              <a:rPr lang="en-GB" sz="1100" dirty="0" smtClean="0"/>
              <a:t>cohort. Correlation between % </a:t>
            </a:r>
            <a:r>
              <a:rPr lang="en-GB" sz="1100" dirty="0" smtClean="0"/>
              <a:t>CD7dim/negative </a:t>
            </a:r>
            <a:r>
              <a:rPr lang="en-GB" sz="1100" dirty="0" smtClean="0"/>
              <a:t>and (D) proviral load or (E) OCI flow.</a:t>
            </a:r>
            <a:endParaRPr lang="en-GB" sz="1100" dirty="0"/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40453381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297</TotalTime>
  <Words>1669</Words>
  <Application>Microsoft Office PowerPoint</Application>
  <PresentationFormat>On-screen Show (4:3)</PresentationFormat>
  <Paragraphs>480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1_Office Theme</vt:lpstr>
      <vt:lpstr>Prism 9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S fig 2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lf, Sonia N</dc:creator>
  <cp:lastModifiedBy>Rowan, Aileen</cp:lastModifiedBy>
  <cp:revision>400</cp:revision>
  <cp:lastPrinted>2021-02-21T12:03:22Z</cp:lastPrinted>
  <dcterms:created xsi:type="dcterms:W3CDTF">2019-09-20T13:30:55Z</dcterms:created>
  <dcterms:modified xsi:type="dcterms:W3CDTF">2021-02-22T17:45:43Z</dcterms:modified>
</cp:coreProperties>
</file>